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8E29C9-3A6C-4DA3-B82D-968C3A59B6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D3B4A3-636F-452E-81F2-5612A78129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B7FF41-620A-40E9-A3C3-12EBCE1454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754813-50D4-4781-B409-95AB9E59F0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85DBC-A1F6-4B50-A42D-430C666DE6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708064-CFCA-4114-975C-63078DC34E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1A25F6-EF79-4340-BCC2-1329ED7456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6414EE-F15C-4D75-AAE8-F323EDD536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3798BD-B4CB-4171-9254-E8CF03A94A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9EEF60-71FF-4685-977D-9154681217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72BB2A-BE41-41CE-9A76-78693CD1FA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ACC743-CC12-49C9-A538-7DADE639B8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E6DEB2-5679-4263-8BB4-38BD863C3B8D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15026" r="0" b="0"/>
          <a:stretch/>
        </p:blipFill>
        <p:spPr>
          <a:xfrm>
            <a:off x="0" y="0"/>
            <a:ext cx="9144000" cy="56275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984040" y="6020640"/>
            <a:ext cx="317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2: System Home Pag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rcRect l="0" t="12362" r="0" b="0"/>
          <a:stretch/>
        </p:blipFill>
        <p:spPr>
          <a:xfrm>
            <a:off x="0" y="0"/>
            <a:ext cx="9144000" cy="579600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1035000" y="6157080"/>
            <a:ext cx="707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3: First screen in an introductory series on first visit to syste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rcRect l="0" t="15026" r="0" b="0"/>
          <a:stretch/>
        </p:blipFill>
        <p:spPr>
          <a:xfrm>
            <a:off x="0" y="0"/>
            <a:ext cx="9144000" cy="562752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1804680" y="6092280"/>
            <a:ext cx="553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4: First screen of weekly welcome back seri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rcRect l="0" t="6062" r="0" b="0"/>
          <a:stretch/>
        </p:blipFill>
        <p:spPr>
          <a:xfrm>
            <a:off x="0" y="0"/>
            <a:ext cx="9144000" cy="622296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1685880" y="6301800"/>
            <a:ext cx="5772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5: Weekly schedule for planning physical activ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rcRect l="0" t="12530" r="0" b="0"/>
          <a:stretch/>
        </p:blipFill>
        <p:spPr>
          <a:xfrm>
            <a:off x="0" y="206280"/>
            <a:ext cx="9144000" cy="552780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1996560" y="6014160"/>
            <a:ext cx="5150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6: Text based automated dialogue modu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rcRect l="0" t="11914" r="0" b="0"/>
          <a:stretch/>
        </p:blipFill>
        <p:spPr>
          <a:xfrm>
            <a:off x="0" y="0"/>
            <a:ext cx="9144000" cy="571968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30240" y="173052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0240" y="173052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702880" y="6112800"/>
            <a:ext cx="3341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7: Weekly activity chart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3-16T13:06:53Z</dcterms:created>
  <dc:creator>Unilever</dc:creator>
  <dc:description/>
  <dc:language>en-US</dc:language>
  <cp:lastModifiedBy>乩歫椠䱡畳椀㸲㻸ꔿ㌋䬮ꍰ䞮誀圇짗꾬钒붤鏊꣊㥊揤鞁</cp:lastModifiedBy>
  <dcterms:modified xsi:type="dcterms:W3CDTF">2007-04-27T20:54:45Z</dcterms:modified>
  <cp:revision>7</cp:revision>
  <dc:subject/>
  <dc:title>Slide 1</dc:title>
</cp:coreProperties>
</file>